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1579" y="5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10/07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7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7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7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7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7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7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7/2025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7/2025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7/2025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7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7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10/07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2576" y="5707248"/>
            <a:ext cx="722372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Russ-Silsby et al (2025) Diabetologia DOI 10.1007/s00125-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025-06495-3 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5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07504" y="44624"/>
            <a:ext cx="871296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No. of scientific journal articles matching the terms ‘monogenic diabetes’, ‘maturity-onset diabetes of the young’ or ‘neonatal diabetes’ (and variations thereof) in Scopus up to 2000 (a) and from 2000 onwards (b) by country (based on all named author affiliations)</a:t>
            </a:r>
            <a:endParaRPr lang="en-GB" sz="1800" b="1" dirty="0"/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F73A113A-38D9-85F1-F94D-D674EAC1730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128771" y="1104959"/>
            <a:ext cx="4886459" cy="44842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96</Words>
  <Application>Microsoft Office PowerPoint</Application>
  <PresentationFormat>On-screen Show (4:3)</PresentationFormat>
  <Paragraphs>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Judy Naylor</cp:lastModifiedBy>
  <cp:revision>47</cp:revision>
  <dcterms:created xsi:type="dcterms:W3CDTF">2016-06-15T12:53:43Z</dcterms:created>
  <dcterms:modified xsi:type="dcterms:W3CDTF">2025-07-10T09:04:45Z</dcterms:modified>
</cp:coreProperties>
</file>